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4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621" autoAdjust="0"/>
    <p:restoredTop sz="94783"/>
  </p:normalViewPr>
  <p:slideViewPr>
    <p:cSldViewPr snapToGrid="0">
      <p:cViewPr varScale="1">
        <p:scale>
          <a:sx n="137" d="100"/>
          <a:sy n="137" d="100"/>
        </p:scale>
        <p:origin x="84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B150455-91CE-49BC-822F-4D311C84909B}" type="datetimeFigureOut">
              <a:rPr lang="en-US" smtClean="0"/>
              <a:t>9/2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B6B72F-D5C8-4BE7-8CC2-5648AA7C55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1896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cale bar = 200 um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EB6B72F-D5C8-4BE7-8CC2-5648AA7C550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71994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8C586BC-2B58-56AC-E22C-D564787DDFA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5B719BE7-8743-8FCA-BD0B-FE715EB48E73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7F1CC753-5745-DBC1-31DF-8ECF08957186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cale bar = 200 um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D73C32E-6CF6-DFEA-993A-BC02B52040E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EB6B72F-D5C8-4BE7-8CC2-5648AA7C550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4730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DC50A4-24A8-D489-26DD-ED8D34B64CC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B726EF4-10A6-D6EA-1673-80BCAE43C9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BCB6C8-5AE7-2BA5-9D4B-07782B62FE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5F529-9A8F-40EA-AE9D-879E31173B67}" type="datetimeFigureOut">
              <a:rPr lang="en-US" smtClean="0"/>
              <a:t>9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D06A57-AE2E-373E-8F61-835192213A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C9C056-9F72-1203-159F-333543F046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42F84-205F-4152-AF6B-E8E74513C8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85823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4C9249-E814-7DC7-DA29-512FB865A8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B6DD2DD-1CB5-6905-774A-6E25F9918A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D581E7-F3C9-64E9-33DF-F62999FE4C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5F529-9A8F-40EA-AE9D-879E31173B67}" type="datetimeFigureOut">
              <a:rPr lang="en-US" smtClean="0"/>
              <a:t>9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8D3315-E095-EB49-5B79-E04A7C7B87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78C5D9-B160-E93D-518D-1609B04FA6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42F84-205F-4152-AF6B-E8E74513C8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4448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CC5B768-2BCB-C990-7139-235528CD28D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08CEEDD-F76B-9017-FB1A-BE9C858645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AAA875-D420-DE59-A424-B09DA8497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5F529-9A8F-40EA-AE9D-879E31173B67}" type="datetimeFigureOut">
              <a:rPr lang="en-US" smtClean="0"/>
              <a:t>9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D90F50-2F8A-21B8-1BE7-783E03BC54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A89E60-208F-D749-EBCA-EE013E5FD7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42F84-205F-4152-AF6B-E8E74513C8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15758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C23D70-9DC0-3B8D-253F-AF9B32A932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689FE2-C738-D091-E4C9-538FEFD266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807A00-C357-3DB7-B244-5782A9D95D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5F529-9A8F-40EA-AE9D-879E31173B67}" type="datetimeFigureOut">
              <a:rPr lang="en-US" smtClean="0"/>
              <a:t>9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A7D7FE-751C-5A43-9531-D5B79ED5D1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8FE834-395C-907C-41B0-33B70B4B9B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42F84-205F-4152-AF6B-E8E74513C8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17969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FDD3D5-C482-D892-D0E3-B913E4E9D7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04CB36-E82F-9FCC-69D9-94B139356E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47913B-E016-74A4-625B-48E1C3F53F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5F529-9A8F-40EA-AE9D-879E31173B67}" type="datetimeFigureOut">
              <a:rPr lang="en-US" smtClean="0"/>
              <a:t>9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4C523B-C27D-4C4D-DA12-D69647C966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BC5E7F-1EF0-A8B0-EC85-1859145BED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42F84-205F-4152-AF6B-E8E74513C8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755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026C6A-E149-6B93-6A32-5F99EDC613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C52E10-DC7B-47E4-8041-9ED0B48922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5564B85-EA43-8D28-C787-2C161B4F61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5E126C-0830-74CD-8387-97FE627F0A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5F529-9A8F-40EA-AE9D-879E31173B67}" type="datetimeFigureOut">
              <a:rPr lang="en-US" smtClean="0"/>
              <a:t>9/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0AF21C-2F44-11BE-3BF6-07EFA54E96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EAB099-856C-5169-7D91-7C0C6E1E7A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42F84-205F-4152-AF6B-E8E74513C8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1564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FF949C-F3ED-65FE-26A5-742A536FD1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E1F90C-486B-EA04-150C-6089E7094C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778C3CF-DA3D-02DA-222F-2C789BB167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667861F-DD13-C947-0CBF-D031908FC0A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5D20E5F-86F3-3E5E-0401-1B383155434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3B39EF6-7881-8D21-0892-F865A15469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5F529-9A8F-40EA-AE9D-879E31173B67}" type="datetimeFigureOut">
              <a:rPr lang="en-US" smtClean="0"/>
              <a:t>9/2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57FC691-7086-8007-9BDC-8BB157F8E8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F3707DC-71A8-7058-9931-56AABE1358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42F84-205F-4152-AF6B-E8E74513C8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49853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894302-8D29-390F-31AC-3B7C3C6F7A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92540FB-9634-32D2-7FD2-1D3514F838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5F529-9A8F-40EA-AE9D-879E31173B67}" type="datetimeFigureOut">
              <a:rPr lang="en-US" smtClean="0"/>
              <a:t>9/2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26D1C71-F846-CADA-1A51-4EB07A8CBE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B4A829E-0269-65A3-0551-E6007FE7C9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42F84-205F-4152-AF6B-E8E74513C8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50342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03D8E98-0BFD-8463-99DA-728F8576A7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5F529-9A8F-40EA-AE9D-879E31173B67}" type="datetimeFigureOut">
              <a:rPr lang="en-US" smtClean="0"/>
              <a:t>9/2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E78E4D6-284D-2E27-320C-6E5B22A869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D8B3541-0471-C20B-F37F-222BBF719B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42F84-205F-4152-AF6B-E8E74513C8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93243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1B6278-3574-CA81-B537-54693D0F77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1DE49D-DAC8-CC51-8A41-F6144317755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46F6D2-BC78-53AB-ADD6-3C14376FED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BECF09-350D-0998-AE74-71B59DBA6B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5F529-9A8F-40EA-AE9D-879E31173B67}" type="datetimeFigureOut">
              <a:rPr lang="en-US" smtClean="0"/>
              <a:t>9/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DAE9700-7B2D-17BC-CFB1-FC55E110B5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3A8A92-2E67-C3CF-D7DF-1CA2E7590C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42F84-205F-4152-AF6B-E8E74513C8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1813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F0EEE7-27CB-DBA1-D738-CECB10B8A9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A27F558-4162-E981-A5B2-7C1C94232E3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F78CFA0-2124-C09F-84AF-3C169883DF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03B3AB0-4FB1-FBEA-84C6-FFECAE1D90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5F529-9A8F-40EA-AE9D-879E31173B67}" type="datetimeFigureOut">
              <a:rPr lang="en-US" smtClean="0"/>
              <a:t>9/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FC72BF-ABD1-3215-95A2-5B84B6A5BD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195F98-CF09-E8B0-D22B-FB88955C77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42F84-205F-4152-AF6B-E8E74513C8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12620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251167E-B7E0-0D01-E421-C9C0441F46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C564A6-355F-5488-700B-3D60A51504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9F5835-5640-D2AA-6241-DB949416E9F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C5F529-9A8F-40EA-AE9D-879E31173B67}" type="datetimeFigureOut">
              <a:rPr lang="en-US" smtClean="0"/>
              <a:t>9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7E0A1E-5880-7854-2F3E-A50301DF12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7161CD-F94B-3EDA-E799-6A7370A975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142F84-205F-4152-AF6B-E8E74513C8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83184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243BE0F4-547C-4C42-A1DF-E4D4DCD32E0F}"/>
              </a:ext>
            </a:extLst>
          </p:cNvPr>
          <p:cNvSpPr txBox="1">
            <a:spLocks/>
          </p:cNvSpPr>
          <p:nvPr/>
        </p:nvSpPr>
        <p:spPr>
          <a:xfrm>
            <a:off x="838200" y="267406"/>
            <a:ext cx="10515600" cy="517148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dirty="0"/>
              <a:t>HSA (Control)</a:t>
            </a:r>
          </a:p>
        </p:txBody>
      </p:sp>
      <p:pic>
        <p:nvPicPr>
          <p:cNvPr id="9" name="Picture 8" descr="A pink and black cell&#10;&#10;Description automatically generated with medium confidence">
            <a:extLst>
              <a:ext uri="{FF2B5EF4-FFF2-40B4-BE49-F238E27FC236}">
                <a16:creationId xmlns:a16="http://schemas.microsoft.com/office/drawing/2014/main" id="{EC906BEF-C829-868D-66E2-580854917DF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2549" y="905316"/>
            <a:ext cx="4140200" cy="5531579"/>
          </a:xfrm>
          <a:prstGeom prst="rect">
            <a:avLst/>
          </a:prstGeom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4FB98729-2096-3F62-D41B-D305744E6644}"/>
              </a:ext>
            </a:extLst>
          </p:cNvPr>
          <p:cNvSpPr/>
          <p:nvPr/>
        </p:nvSpPr>
        <p:spPr>
          <a:xfrm>
            <a:off x="6348699" y="1880772"/>
            <a:ext cx="752475" cy="755650"/>
          </a:xfrm>
          <a:prstGeom prst="rect">
            <a:avLst/>
          </a:prstGeom>
          <a:noFill/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759B66C-098B-7CA9-F3A1-E6F737CCB89A}"/>
              </a:ext>
            </a:extLst>
          </p:cNvPr>
          <p:cNvSpPr txBox="1"/>
          <p:nvPr/>
        </p:nvSpPr>
        <p:spPr>
          <a:xfrm>
            <a:off x="950495" y="5546558"/>
            <a:ext cx="20333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cale bar= 200um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B8CDAF4-2B1E-3155-710E-570619CA4FCF}"/>
              </a:ext>
            </a:extLst>
          </p:cNvPr>
          <p:cNvSpPr txBox="1"/>
          <p:nvPr/>
        </p:nvSpPr>
        <p:spPr>
          <a:xfrm>
            <a:off x="1174102" y="1238925"/>
            <a:ext cx="20333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= Dystrophin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5822D73-50F3-FA5C-2AB1-CA2B6D08B727}"/>
              </a:ext>
            </a:extLst>
          </p:cNvPr>
          <p:cNvSpPr txBox="1"/>
          <p:nvPr/>
        </p:nvSpPr>
        <p:spPr>
          <a:xfrm>
            <a:off x="1174101" y="1567443"/>
            <a:ext cx="20333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= </a:t>
            </a:r>
            <a:r>
              <a:rPr lang="en-US" dirty="0" err="1"/>
              <a:t>MyHC</a:t>
            </a:r>
            <a:r>
              <a:rPr lang="en-US" dirty="0"/>
              <a:t> I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5F1214A-247F-53CB-48C2-B05457FB906F}"/>
              </a:ext>
            </a:extLst>
          </p:cNvPr>
          <p:cNvSpPr txBox="1"/>
          <p:nvPr/>
        </p:nvSpPr>
        <p:spPr>
          <a:xfrm>
            <a:off x="269728" y="1238925"/>
            <a:ext cx="20333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40FF"/>
                </a:solidFill>
              </a:rPr>
              <a:t>Magent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6631044-213C-9FD4-74E2-258185C5C7C3}"/>
              </a:ext>
            </a:extLst>
          </p:cNvPr>
          <p:cNvSpPr txBox="1"/>
          <p:nvPr/>
        </p:nvSpPr>
        <p:spPr>
          <a:xfrm>
            <a:off x="269727" y="1567443"/>
            <a:ext cx="20333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Re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DBC42EE-716D-CC38-71E9-E94E25BB0838}"/>
              </a:ext>
            </a:extLst>
          </p:cNvPr>
          <p:cNvSpPr txBox="1"/>
          <p:nvPr/>
        </p:nvSpPr>
        <p:spPr>
          <a:xfrm>
            <a:off x="1174101" y="2265293"/>
            <a:ext cx="20333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= Area Fig. 6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BD954E60-0C9C-68CB-F5F6-B2F18D099897}"/>
              </a:ext>
            </a:extLst>
          </p:cNvPr>
          <p:cNvSpPr>
            <a:spLocks/>
          </p:cNvSpPr>
          <p:nvPr/>
        </p:nvSpPr>
        <p:spPr>
          <a:xfrm>
            <a:off x="353703" y="2265293"/>
            <a:ext cx="355424" cy="369332"/>
          </a:xfrm>
          <a:prstGeom prst="rect">
            <a:avLst/>
          </a:prstGeom>
          <a:noFill/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28268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FF250B3-ED63-DE10-AA05-F73B801DEBA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nk and purple cell&#10;&#10;Description automatically generated with medium confidence">
            <a:extLst>
              <a:ext uri="{FF2B5EF4-FFF2-40B4-BE49-F238E27FC236}">
                <a16:creationId xmlns:a16="http://schemas.microsoft.com/office/drawing/2014/main" id="{663A388E-FBD1-D85A-6CC0-4CB67BD57F7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01055" y="1118517"/>
            <a:ext cx="5989890" cy="5424178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030C51A5-C27A-A31E-6C6D-C53E9A2E4F27}"/>
              </a:ext>
            </a:extLst>
          </p:cNvPr>
          <p:cNvSpPr>
            <a:spLocks/>
          </p:cNvSpPr>
          <p:nvPr/>
        </p:nvSpPr>
        <p:spPr>
          <a:xfrm>
            <a:off x="4419599" y="4255965"/>
            <a:ext cx="749808" cy="758952"/>
          </a:xfrm>
          <a:prstGeom prst="rect">
            <a:avLst/>
          </a:prstGeom>
          <a:noFill/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9A854371-81CE-C25D-FE40-09A9482AB794}"/>
              </a:ext>
            </a:extLst>
          </p:cNvPr>
          <p:cNvSpPr txBox="1">
            <a:spLocks/>
          </p:cNvSpPr>
          <p:nvPr/>
        </p:nvSpPr>
        <p:spPr>
          <a:xfrm>
            <a:off x="838200" y="267406"/>
            <a:ext cx="10515600" cy="517148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dirty="0"/>
              <a:t>HSA-MY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B571E70-9578-B7B7-2FBE-4D82F50488F4}"/>
              </a:ext>
            </a:extLst>
          </p:cNvPr>
          <p:cNvSpPr txBox="1"/>
          <p:nvPr/>
        </p:nvSpPr>
        <p:spPr>
          <a:xfrm>
            <a:off x="950495" y="5546558"/>
            <a:ext cx="20333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cale bar= 200um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087E9C6-9085-C8DB-78F3-8A138B78BCF5}"/>
              </a:ext>
            </a:extLst>
          </p:cNvPr>
          <p:cNvSpPr txBox="1"/>
          <p:nvPr/>
        </p:nvSpPr>
        <p:spPr>
          <a:xfrm>
            <a:off x="1174102" y="1238925"/>
            <a:ext cx="20333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= Dystrophi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9B84C11-54F6-7B92-3EF8-48FA046DD193}"/>
              </a:ext>
            </a:extLst>
          </p:cNvPr>
          <p:cNvSpPr txBox="1"/>
          <p:nvPr/>
        </p:nvSpPr>
        <p:spPr>
          <a:xfrm>
            <a:off x="1174101" y="1567443"/>
            <a:ext cx="20333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= </a:t>
            </a:r>
            <a:r>
              <a:rPr lang="en-US" dirty="0" err="1"/>
              <a:t>MyHC</a:t>
            </a:r>
            <a:r>
              <a:rPr lang="en-US" dirty="0"/>
              <a:t> I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187581A-828F-34C7-2B83-55B073E35666}"/>
              </a:ext>
            </a:extLst>
          </p:cNvPr>
          <p:cNvSpPr txBox="1"/>
          <p:nvPr/>
        </p:nvSpPr>
        <p:spPr>
          <a:xfrm>
            <a:off x="269728" y="1238925"/>
            <a:ext cx="20333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40FF"/>
                </a:solidFill>
              </a:rPr>
              <a:t>Magent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20D614C-9E2C-E805-4CCF-7EC00C02D3D1}"/>
              </a:ext>
            </a:extLst>
          </p:cNvPr>
          <p:cNvSpPr txBox="1"/>
          <p:nvPr/>
        </p:nvSpPr>
        <p:spPr>
          <a:xfrm>
            <a:off x="269727" y="1567443"/>
            <a:ext cx="20333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Re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C585DD9-534D-48F2-3E24-5D3EDAB579B4}"/>
              </a:ext>
            </a:extLst>
          </p:cNvPr>
          <p:cNvSpPr txBox="1"/>
          <p:nvPr/>
        </p:nvSpPr>
        <p:spPr>
          <a:xfrm>
            <a:off x="1174101" y="2265293"/>
            <a:ext cx="20333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= Area Fig. 6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D92CDFEB-E72A-6EDC-AF55-F1766D0579DC}"/>
              </a:ext>
            </a:extLst>
          </p:cNvPr>
          <p:cNvSpPr>
            <a:spLocks/>
          </p:cNvSpPr>
          <p:nvPr/>
        </p:nvSpPr>
        <p:spPr>
          <a:xfrm>
            <a:off x="353703" y="2265293"/>
            <a:ext cx="355424" cy="369332"/>
          </a:xfrm>
          <a:prstGeom prst="rect">
            <a:avLst/>
          </a:prstGeom>
          <a:noFill/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0891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49</Words>
  <Application>Microsoft Macintosh PowerPoint</Application>
  <PresentationFormat>Widescreen</PresentationFormat>
  <Paragraphs>18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oshua Rorke</dc:creator>
  <cp:lastModifiedBy>Sebastian Edman</cp:lastModifiedBy>
  <cp:revision>5</cp:revision>
  <dcterms:created xsi:type="dcterms:W3CDTF">2024-08-28T14:06:18Z</dcterms:created>
  <dcterms:modified xsi:type="dcterms:W3CDTF">2024-09-02T06:36:56Z</dcterms:modified>
</cp:coreProperties>
</file>